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34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80" userDrawn="1">
          <p15:clr>
            <a:srgbClr val="A4A3A4"/>
          </p15:clr>
        </p15:guide>
        <p15:guide id="2" pos="240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667" autoAdjust="0"/>
    <p:restoredTop sz="94590"/>
  </p:normalViewPr>
  <p:slideViewPr>
    <p:cSldViewPr snapToGrid="0" snapToObjects="1">
      <p:cViewPr varScale="1">
        <p:scale>
          <a:sx n="59" d="100"/>
          <a:sy n="59" d="100"/>
        </p:scale>
        <p:origin x="2611" y="58"/>
      </p:cViewPr>
      <p:guideLst>
        <p:guide orient="horz" pos="480"/>
        <p:guide pos="240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6F2C6B-841C-4E54-84DF-10BA70DE4694}" type="datetimeFigureOut">
              <a:rPr lang="en-US" smtClean="0"/>
              <a:t>8/7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C440DA-989F-424F-AC98-F8222F905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07262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EC440DA-989F-424F-AC98-F8222F9051E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44258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8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80107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8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391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8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663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8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88941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8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3126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8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5317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8/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8328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8/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17750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8/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20806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8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0537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8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90469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306FF8-9852-E74D-8D99-EBBEDB98C96D}" type="datetimeFigureOut">
              <a:rPr lang="en-US" smtClean="0"/>
              <a:t>8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4374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Picture 31">
            <a:extLst>
              <a:ext uri="{FF2B5EF4-FFF2-40B4-BE49-F238E27FC236}">
                <a16:creationId xmlns:a16="http://schemas.microsoft.com/office/drawing/2014/main" id="{D472891E-DDFA-42EB-A970-69823052843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/>
          <a:srcRect l="17263" t="14432" b="15909"/>
          <a:stretch/>
        </p:blipFill>
        <p:spPr>
          <a:xfrm>
            <a:off x="767118" y="4378680"/>
            <a:ext cx="1947672" cy="1344168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977726B7-E600-46FC-92DB-E390E0EE5530}"/>
              </a:ext>
            </a:extLst>
          </p:cNvPr>
          <p:cNvSpPr txBox="1"/>
          <p:nvPr/>
        </p:nvSpPr>
        <p:spPr>
          <a:xfrm>
            <a:off x="2999767" y="4305529"/>
            <a:ext cx="75854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iSC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iGAB1#1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925060C8-C54E-4C64-8E9C-CDEAA6D77AD3}"/>
              </a:ext>
            </a:extLst>
          </p:cNvPr>
          <p:cNvSpPr>
            <a:spLocks noChangeAspect="1"/>
          </p:cNvSpPr>
          <p:nvPr/>
        </p:nvSpPr>
        <p:spPr>
          <a:xfrm>
            <a:off x="2958741" y="4569168"/>
            <a:ext cx="91617" cy="54864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1C1292CD-D864-45A3-A133-CF7579C697B6}"/>
              </a:ext>
            </a:extLst>
          </p:cNvPr>
          <p:cNvSpPr>
            <a:spLocks noChangeAspect="1"/>
          </p:cNvSpPr>
          <p:nvPr/>
        </p:nvSpPr>
        <p:spPr>
          <a:xfrm>
            <a:off x="2958741" y="4421354"/>
            <a:ext cx="91617" cy="54864"/>
          </a:xfrm>
          <a:prstGeom prst="rect">
            <a:avLst/>
          </a:prstGeom>
          <a:solidFill>
            <a:schemeClr val="tx1"/>
          </a:solidFill>
          <a:ln/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E394C5EC-74C7-468D-B1A8-2D4AD4949215}"/>
              </a:ext>
            </a:extLst>
          </p:cNvPr>
          <p:cNvSpPr txBox="1"/>
          <p:nvPr/>
        </p:nvSpPr>
        <p:spPr>
          <a:xfrm>
            <a:off x="2317906" y="5087522"/>
            <a:ext cx="4219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EF8DFD7-2DF7-4930-A4D0-37D7352F4B78}"/>
              </a:ext>
            </a:extLst>
          </p:cNvPr>
          <p:cNvSpPr txBox="1"/>
          <p:nvPr/>
        </p:nvSpPr>
        <p:spPr>
          <a:xfrm rot="16200000">
            <a:off x="855983" y="5850492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BA2BF8BD-A7D7-4890-80D6-913D3A9DFC34}"/>
              </a:ext>
            </a:extLst>
          </p:cNvPr>
          <p:cNvSpPr txBox="1"/>
          <p:nvPr/>
        </p:nvSpPr>
        <p:spPr>
          <a:xfrm rot="16200000">
            <a:off x="1124685" y="6049841"/>
            <a:ext cx="7548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Epiregul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806E503C-D528-4568-B6FB-1FD853D2B291}"/>
              </a:ext>
            </a:extLst>
          </p:cNvPr>
          <p:cNvSpPr txBox="1"/>
          <p:nvPr/>
        </p:nvSpPr>
        <p:spPr>
          <a:xfrm rot="16200000">
            <a:off x="1608099" y="5995563"/>
            <a:ext cx="6686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HP099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AB8A831-F741-4BA4-86E4-C3FB8C4BCAD5}"/>
              </a:ext>
            </a:extLst>
          </p:cNvPr>
          <p:cNvSpPr txBox="1"/>
          <p:nvPr/>
        </p:nvSpPr>
        <p:spPr>
          <a:xfrm rot="16200000">
            <a:off x="2114580" y="5804572"/>
            <a:ext cx="752129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Epiregul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     +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HP099</a:t>
            </a: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FF7020FF-33B7-4E4F-991E-B0C496E803C9}"/>
              </a:ext>
            </a:extLst>
          </p:cNvPr>
          <p:cNvCxnSpPr/>
          <p:nvPr/>
        </p:nvCxnSpPr>
        <p:spPr>
          <a:xfrm>
            <a:off x="900354" y="5731846"/>
            <a:ext cx="349007" cy="17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EE8EFC68-C64B-472F-A3C8-FB9A02EBB47A}"/>
              </a:ext>
            </a:extLst>
          </p:cNvPr>
          <p:cNvCxnSpPr/>
          <p:nvPr/>
        </p:nvCxnSpPr>
        <p:spPr>
          <a:xfrm>
            <a:off x="1338504" y="5731846"/>
            <a:ext cx="349007" cy="17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8C053621-A4B1-43E4-B428-0D5D3663E4B2}"/>
              </a:ext>
            </a:extLst>
          </p:cNvPr>
          <p:cNvCxnSpPr/>
          <p:nvPr/>
        </p:nvCxnSpPr>
        <p:spPr>
          <a:xfrm>
            <a:off x="1776654" y="5731846"/>
            <a:ext cx="349007" cy="17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97E058D8-B932-4B08-B2A1-63C5A0963F42}"/>
              </a:ext>
            </a:extLst>
          </p:cNvPr>
          <p:cNvCxnSpPr/>
          <p:nvPr/>
        </p:nvCxnSpPr>
        <p:spPr>
          <a:xfrm>
            <a:off x="2214804" y="5731846"/>
            <a:ext cx="349007" cy="17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1841E6BD-F59E-4278-BCEF-37B2D8720816}"/>
              </a:ext>
            </a:extLst>
          </p:cNvPr>
          <p:cNvSpPr txBox="1">
            <a:spLocks/>
          </p:cNvSpPr>
          <p:nvPr/>
        </p:nvSpPr>
        <p:spPr>
          <a:xfrm rot="16200000">
            <a:off x="5233582" y="4527230"/>
            <a:ext cx="7585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iGAB1#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3DB293DA-2BF2-4D97-AC4B-1135713A676F}"/>
              </a:ext>
            </a:extLst>
          </p:cNvPr>
          <p:cNvSpPr txBox="1">
            <a:spLocks/>
          </p:cNvSpPr>
          <p:nvPr/>
        </p:nvSpPr>
        <p:spPr>
          <a:xfrm>
            <a:off x="5501832" y="4066209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C-9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1306D5F4-EF09-44CA-9291-1382380D70C5}"/>
              </a:ext>
            </a:extLst>
          </p:cNvPr>
          <p:cNvSpPr txBox="1"/>
          <p:nvPr/>
        </p:nvSpPr>
        <p:spPr>
          <a:xfrm>
            <a:off x="4647203" y="5402811"/>
            <a:ext cx="880369" cy="32316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-AKT (473)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A0DBCE0-F4CB-4A19-AA94-478554135C14}"/>
              </a:ext>
            </a:extLst>
          </p:cNvPr>
          <p:cNvSpPr txBox="1">
            <a:spLocks/>
          </p:cNvSpPr>
          <p:nvPr/>
        </p:nvSpPr>
        <p:spPr>
          <a:xfrm rot="16200000">
            <a:off x="5813743" y="4710720"/>
            <a:ext cx="4555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iSC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6081944-CFA1-4ABB-8D6E-13BC1485486B}"/>
              </a:ext>
            </a:extLst>
          </p:cNvPr>
          <p:cNvSpPr txBox="1"/>
          <p:nvPr/>
        </p:nvSpPr>
        <p:spPr>
          <a:xfrm>
            <a:off x="5003069" y="4945852"/>
            <a:ext cx="524503" cy="32316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AB1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59BD0131-1FF9-41D1-BFA5-DBBAD9E212A5}"/>
              </a:ext>
            </a:extLst>
          </p:cNvPr>
          <p:cNvSpPr txBox="1"/>
          <p:nvPr/>
        </p:nvSpPr>
        <p:spPr>
          <a:xfrm>
            <a:off x="4385913" y="5182379"/>
            <a:ext cx="1141659" cy="2946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-ERK (202/204)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56AA7561-5841-42C5-A6F5-F0E4F38A6D3D}"/>
              </a:ext>
            </a:extLst>
          </p:cNvPr>
          <p:cNvSpPr txBox="1"/>
          <p:nvPr/>
        </p:nvSpPr>
        <p:spPr>
          <a:xfrm>
            <a:off x="4887653" y="5652633"/>
            <a:ext cx="639919" cy="32316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A2DD9E65-8E10-4E93-B753-52B6C6BDED13}"/>
              </a:ext>
            </a:extLst>
          </p:cNvPr>
          <p:cNvSpPr txBox="1"/>
          <p:nvPr/>
        </p:nvSpPr>
        <p:spPr>
          <a:xfrm>
            <a:off x="1534643" y="4069700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C-9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9403E400-9D46-4567-8CAB-999F231F3E1E}"/>
              </a:ext>
            </a:extLst>
          </p:cNvPr>
          <p:cNvSpPr txBox="1"/>
          <p:nvPr/>
        </p:nvSpPr>
        <p:spPr>
          <a:xfrm rot="16200000">
            <a:off x="-181448" y="4851322"/>
            <a:ext cx="10663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% Cell Viability 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17AEB408-3993-4B60-B430-9B9862697576}"/>
              </a:ext>
            </a:extLst>
          </p:cNvPr>
          <p:cNvSpPr txBox="1"/>
          <p:nvPr/>
        </p:nvSpPr>
        <p:spPr>
          <a:xfrm>
            <a:off x="523167" y="5126003"/>
            <a:ext cx="4598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0109F266-53E0-4C12-B26D-4C57209A08B1}"/>
              </a:ext>
            </a:extLst>
          </p:cNvPr>
          <p:cNvSpPr txBox="1"/>
          <p:nvPr/>
        </p:nvSpPr>
        <p:spPr>
          <a:xfrm>
            <a:off x="451145" y="4328705"/>
            <a:ext cx="4598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A98477BE-36D0-41B5-8C15-D1A8FB3ACDF7}"/>
              </a:ext>
            </a:extLst>
          </p:cNvPr>
          <p:cNvSpPr txBox="1"/>
          <p:nvPr/>
        </p:nvSpPr>
        <p:spPr>
          <a:xfrm>
            <a:off x="529562" y="5519986"/>
            <a:ext cx="4598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0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4D4852EB-9E1B-461B-A0D4-03A39851F8D5}"/>
              </a:ext>
            </a:extLst>
          </p:cNvPr>
          <p:cNvSpPr txBox="1"/>
          <p:nvPr/>
        </p:nvSpPr>
        <p:spPr>
          <a:xfrm>
            <a:off x="454147" y="4722496"/>
            <a:ext cx="4598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pic>
        <p:nvPicPr>
          <p:cNvPr id="58" name="Picture 57">
            <a:extLst>
              <a:ext uri="{FF2B5EF4-FFF2-40B4-BE49-F238E27FC236}">
                <a16:creationId xmlns:a16="http://schemas.microsoft.com/office/drawing/2014/main" id="{D015FDEE-FEF8-45EA-BC4D-12A87FDB253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1573"/>
          <a:stretch/>
        </p:blipFill>
        <p:spPr>
          <a:xfrm>
            <a:off x="5473854" y="5020477"/>
            <a:ext cx="786384" cy="1737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9" name="Picture 58">
            <a:extLst>
              <a:ext uri="{FF2B5EF4-FFF2-40B4-BE49-F238E27FC236}">
                <a16:creationId xmlns:a16="http://schemas.microsoft.com/office/drawing/2014/main" id="{493F57E8-1403-46FF-B382-12A70F6C00D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" r="31573" b="-3338"/>
          <a:stretch/>
        </p:blipFill>
        <p:spPr>
          <a:xfrm>
            <a:off x="5473854" y="5268168"/>
            <a:ext cx="786384" cy="1737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0" name="Picture 59">
            <a:extLst>
              <a:ext uri="{FF2B5EF4-FFF2-40B4-BE49-F238E27FC236}">
                <a16:creationId xmlns:a16="http://schemas.microsoft.com/office/drawing/2014/main" id="{AE2ADF79-426F-4347-BB13-C04FCA528AA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1573" b="-31323"/>
          <a:stretch/>
        </p:blipFill>
        <p:spPr>
          <a:xfrm>
            <a:off x="5473854" y="5507484"/>
            <a:ext cx="786384" cy="1737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A70F3085-D88E-4BD7-B4AF-D41771C4535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1573" b="-16534"/>
          <a:stretch/>
        </p:blipFill>
        <p:spPr>
          <a:xfrm>
            <a:off x="5473854" y="5741370"/>
            <a:ext cx="786384" cy="17373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2" name="TextBox 264">
            <a:extLst>
              <a:ext uri="{FF2B5EF4-FFF2-40B4-BE49-F238E27FC236}">
                <a16:creationId xmlns:a16="http://schemas.microsoft.com/office/drawing/2014/main" id="{008EE3AC-46B9-444A-911A-95FCF854CAD8}"/>
              </a:ext>
            </a:extLst>
          </p:cNvPr>
          <p:cNvSpPr txBox="1"/>
          <p:nvPr/>
        </p:nvSpPr>
        <p:spPr>
          <a:xfrm>
            <a:off x="179021" y="3305345"/>
            <a:ext cx="5020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3" name="TextBox 264">
            <a:extLst>
              <a:ext uri="{FF2B5EF4-FFF2-40B4-BE49-F238E27FC236}">
                <a16:creationId xmlns:a16="http://schemas.microsoft.com/office/drawing/2014/main" id="{008EE3AC-46B9-444A-911A-95FCF854CAD8}"/>
              </a:ext>
            </a:extLst>
          </p:cNvPr>
          <p:cNvSpPr txBox="1"/>
          <p:nvPr/>
        </p:nvSpPr>
        <p:spPr>
          <a:xfrm>
            <a:off x="4004298" y="3318755"/>
            <a:ext cx="5020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8A0939D-77C4-F6AA-FD87-C75EED2D4E42}"/>
              </a:ext>
            </a:extLst>
          </p:cNvPr>
          <p:cNvSpPr txBox="1"/>
          <p:nvPr/>
        </p:nvSpPr>
        <p:spPr>
          <a:xfrm>
            <a:off x="179020" y="6842680"/>
            <a:ext cx="6313219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Figure S9.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iological importance of Gab1 in HNSCC cells.</a:t>
            </a:r>
          </a:p>
          <a:p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(A) Top co-dependencies of the GAB1 gene in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epMap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based on the CERES dependency score from CRISPR-Cas9–based viability screens (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vana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Public 20Q3). (B) </a:t>
            </a:r>
            <a:r>
              <a:rPr lang="en-US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CC-9 cells were transiently transfected with either scrambled (SC) or GAB1 siRNA for 24 </a:t>
            </a:r>
            <a:r>
              <a:rPr lang="en-US" sz="1200" dirty="0" err="1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hrs</a:t>
            </a:r>
            <a:r>
              <a:rPr lang="en-US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re-seeded and the next day the cells were treated with or without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10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μM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SHP099</a:t>
            </a:r>
            <a:r>
              <a:rPr lang="en-US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 in the presence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or absence of</a:t>
            </a:r>
            <a:r>
              <a:rPr lang="en-US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50 ng/ml epiregulin </a:t>
            </a:r>
            <a:r>
              <a:rPr lang="en-US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(3 days)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and cell viability was determined by </a:t>
            </a:r>
            <a:r>
              <a:rPr lang="en-US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CellTiter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-Glo.</a:t>
            </a:r>
            <a:r>
              <a:rPr lang="en-US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tatistical significance was determined using two-tailed Student’s t-test. **** p &lt; 0.0001. 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(C) </a:t>
            </a:r>
            <a:r>
              <a:rPr lang="en-US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CC-9 cells were transiently transfected with either GAB1 or scrambled (SC) siRNA for 48 </a:t>
            </a:r>
            <a:r>
              <a:rPr lang="en-US" sz="1200" dirty="0" err="1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hrs</a:t>
            </a:r>
            <a:r>
              <a:rPr lang="en-US" sz="12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and extracted proteins were subjected to western blot analyses with the indicated antibodies.</a:t>
            </a:r>
            <a:endParaRPr lang="en-US" sz="1200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EBEFF3D6-A1B8-F8E8-DBCE-C1A035F7A920}"/>
              </a:ext>
            </a:extLst>
          </p:cNvPr>
          <p:cNvSpPr txBox="1"/>
          <p:nvPr/>
        </p:nvSpPr>
        <p:spPr>
          <a:xfrm>
            <a:off x="136772" y="64502"/>
            <a:ext cx="2612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aphicFrame>
        <p:nvGraphicFramePr>
          <p:cNvPr id="65" name="Table 64">
            <a:extLst>
              <a:ext uri="{FF2B5EF4-FFF2-40B4-BE49-F238E27FC236}">
                <a16:creationId xmlns:a16="http://schemas.microsoft.com/office/drawing/2014/main" id="{C6FAAE08-C9F2-193B-6B06-58DC154F58A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98115031"/>
              </p:ext>
            </p:extLst>
          </p:nvPr>
        </p:nvGraphicFramePr>
        <p:xfrm>
          <a:off x="897799" y="523391"/>
          <a:ext cx="1828801" cy="1958340"/>
        </p:xfrm>
        <a:graphic>
          <a:graphicData uri="http://schemas.openxmlformats.org/drawingml/2006/table">
            <a:tbl>
              <a:tblPr/>
              <a:tblGrid>
                <a:gridCol w="703385">
                  <a:extLst>
                    <a:ext uri="{9D8B030D-6E8A-4147-A177-3AD203B41FA5}">
                      <a16:colId xmlns:a16="http://schemas.microsoft.com/office/drawing/2014/main" val="1033745516"/>
                    </a:ext>
                  </a:extLst>
                </a:gridCol>
                <a:gridCol w="1125416">
                  <a:extLst>
                    <a:ext uri="{9D8B030D-6E8A-4147-A177-3AD203B41FA5}">
                      <a16:colId xmlns:a16="http://schemas.microsoft.com/office/drawing/2014/main" val="409928612"/>
                    </a:ext>
                  </a:extLst>
                </a:gridCol>
              </a:tblGrid>
              <a:tr h="297180">
                <a:tc gridSpan="2"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p Co-dependencies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7632239"/>
                  </a:ext>
                </a:extLst>
              </a:tr>
              <a:tr h="297180">
                <a:tc gridSpan="2"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RISPR (Avana) Public 20Q3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06785803"/>
                  </a:ext>
                </a:extLst>
              </a:tr>
              <a:tr h="29718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e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arson correlation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1255341"/>
                  </a:ext>
                </a:extLst>
              </a:tr>
              <a:tr h="2209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GFR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9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147924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TPN11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9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000260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B2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7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578821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T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1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999229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RFI1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29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912280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365645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55</TotalTime>
  <Words>205</Words>
  <Application>Microsoft Office PowerPoint</Application>
  <PresentationFormat>On-screen Show (4:3)</PresentationFormat>
  <Paragraphs>4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VC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hony Faber</dc:creator>
  <cp:lastModifiedBy>richard</cp:lastModifiedBy>
  <cp:revision>359</cp:revision>
  <cp:lastPrinted>2019-09-23T20:12:05Z</cp:lastPrinted>
  <dcterms:created xsi:type="dcterms:W3CDTF">2019-03-07T03:13:48Z</dcterms:created>
  <dcterms:modified xsi:type="dcterms:W3CDTF">2022-08-08T01:49:04Z</dcterms:modified>
</cp:coreProperties>
</file>